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gif" ContentType="image/gif"/>
  <Default Extension="png" ContentType="image/png"/>
  <Default Extension="svg" ContentType="image/svg+xml"/>
  <Default Extension="bmp" ContentType="image/bmp"/>
  <Default Extension="emf" ContentType="image/x-emf"/>
  <Default Extension="wmf" ContentType="image/x-wmf"/>
  <Default Extension="tiff" ContentType="image/tiff"/>
  <Default Extension="jpg" ContentType="application/octet-stream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slides/slide1.xml" ContentType="application/vnd.openxmlformats-officedocument.presentationml.slide+xml"/>
</Types>
</file>

<file path=_rels/.rels><?xml version="1.0" encoding="UTF-8" standalone="yes"?>

<Relationships  xmlns="http://schemas.openxmlformats.org/package/2006/relationships">
<Relationship Id="rId3" Type="http://schemas.openxmlformats.org/package/2006/relationships/metadata/core-properties" Target="docProps/core.xml"/>
<Relationship Id="rId4" Type="http://schemas.openxmlformats.org/officeDocument/2006/relationships/extended-properties" Target="docProps/app.xml"/>
<Relationship Id="rId1" Type="http://schemas.openxmlformats.org/officeDocument/2006/relationships/officeDocument" Target="ppt/presentation.xml"/>
<Relationship Id="rId2" Type="http://schemas.openxmlformats.org/package/2006/relationships/metadata/thumbnail" Target="docProps/thumbnail.jpeg"/>
</Relationships>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8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1376" y="-1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
<Relationships  xmlns="http://schemas.openxmlformats.org/package/2006/relationships">
<Relationship Id="rId3" Type="http://schemas.openxmlformats.org/officeDocument/2006/relationships/tags" Target="tags/tag1.xml"/>
<Relationship Id="rId4" Type="http://schemas.openxmlformats.org/officeDocument/2006/relationships/presProps" Target="presProps.xml"/>
<Relationship Id="rId5" Type="http://schemas.openxmlformats.org/officeDocument/2006/relationships/viewProps" Target="viewProps.xml"/>
<Relationship Id="rId6" Type="http://schemas.openxmlformats.org/officeDocument/2006/relationships/theme" Target="theme/theme1.xml"/>
<Relationship Id="rId7" Type="http://schemas.openxmlformats.org/officeDocument/2006/relationships/tableStyles" Target="tableStyles.xml"/>
<Relationship Id="rId1" Type="http://schemas.openxmlformats.org/officeDocument/2006/relationships/slideMaster" Target="slideMasters/slideMaster1.xml"/>
<Relationship Id="rId2" Type="http://schemas.openxmlformats.org/officeDocument/2006/relationships/printerSettings" Target="printerSettings/printerSettings1.bin"/>
<Relationship Id="rId8" Type="http://schemas.openxmlformats.org/officeDocument/2006/relationships/slide" Target="slides/slide1.xml"/>
</Relationships>
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
<Relationships  xmlns="http://schemas.openxmlformats.org/package/2006/relationships">
<Relationship Id="rId1" Type="http://schemas.openxmlformats.org/officeDocument/2006/relationships/slideLayout" Target="../slideLayouts/slideLayout2.xml"/>
</Relationships>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/>
              <a:t/>
            </a:r>
          </a:p>
        </p:txBody>
      </p:sp>
      <p:grpSp xmlns:pic="http://schemas.openxmlformats.org/drawingml/2006/picture">
        <p:nvGrpSpPr>
          <p:cNvPr id="3" name=""/>
          <p:cNvGrpSpPr/>
          <p:nvPr/>
        </p:nvGrpSpPr>
        <p:grpSpPr>
          <a:xfrm>
            <a:off x="914400" y="914400"/>
            <a:ext cx="5486400" cy="5486400"/>
            <a:chOff x="914400" y="914400"/>
            <a:chExt cx="5486400" cy="5486400"/>
          </a:xfrm>
        </p:grpSpPr>
        <p:sp>
          <p:nvSpPr>
            <p:cNvPr id="4" name="rc3"/>
            <p:cNvSpPr/>
            <p:nvPr/>
          </p:nvSpPr>
          <p:spPr>
            <a:xfrm>
              <a:off x="914400" y="914400"/>
              <a:ext cx="5486400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" name="rc4"/>
            <p:cNvSpPr/>
            <p:nvPr/>
          </p:nvSpPr>
          <p:spPr>
            <a:xfrm>
              <a:off x="914400" y="914400"/>
              <a:ext cx="5486400" cy="5486399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" name="rc5"/>
            <p:cNvSpPr/>
            <p:nvPr/>
          </p:nvSpPr>
          <p:spPr>
            <a:xfrm>
              <a:off x="1527703" y="1900246"/>
              <a:ext cx="4803507" cy="4100620"/>
            </a:xfrm>
            <a:prstGeom prst="rect">
              <a:avLst/>
            </a:prstGeom>
            <a:solidFill>
              <a:srgbClr val="EBEBEB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7" name="pl6"/>
            <p:cNvSpPr/>
            <p:nvPr/>
          </p:nvSpPr>
          <p:spPr>
            <a:xfrm>
              <a:off x="1527703" y="5428763"/>
              <a:ext cx="4803507" cy="0"/>
            </a:xfrm>
            <a:custGeom>
              <a:avLst/>
              <a:pathLst>
                <a:path w="4803507" h="0">
                  <a:moveTo>
                    <a:pt x="0" y="0"/>
                  </a:moveTo>
                  <a:lnTo>
                    <a:pt x="4803507" y="0"/>
                  </a:lnTo>
                  <a:lnTo>
                    <a:pt x="4803507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" name="pl7"/>
            <p:cNvSpPr/>
            <p:nvPr/>
          </p:nvSpPr>
          <p:spPr>
            <a:xfrm>
              <a:off x="1527703" y="4493324"/>
              <a:ext cx="4803507" cy="0"/>
            </a:xfrm>
            <a:custGeom>
              <a:avLst/>
              <a:pathLst>
                <a:path w="4803507" h="0">
                  <a:moveTo>
                    <a:pt x="0" y="0"/>
                  </a:moveTo>
                  <a:lnTo>
                    <a:pt x="4803507" y="0"/>
                  </a:lnTo>
                  <a:lnTo>
                    <a:pt x="4803507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" name="pl8"/>
            <p:cNvSpPr/>
            <p:nvPr/>
          </p:nvSpPr>
          <p:spPr>
            <a:xfrm>
              <a:off x="1527703" y="3557885"/>
              <a:ext cx="4803507" cy="0"/>
            </a:xfrm>
            <a:custGeom>
              <a:avLst/>
              <a:pathLst>
                <a:path w="4803507" h="0">
                  <a:moveTo>
                    <a:pt x="0" y="0"/>
                  </a:moveTo>
                  <a:lnTo>
                    <a:pt x="4803507" y="0"/>
                  </a:lnTo>
                  <a:lnTo>
                    <a:pt x="4803507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" name="pl9"/>
            <p:cNvSpPr/>
            <p:nvPr/>
          </p:nvSpPr>
          <p:spPr>
            <a:xfrm>
              <a:off x="1527703" y="2622446"/>
              <a:ext cx="4803507" cy="0"/>
            </a:xfrm>
            <a:custGeom>
              <a:avLst/>
              <a:pathLst>
                <a:path w="4803507" h="0">
                  <a:moveTo>
                    <a:pt x="0" y="0"/>
                  </a:moveTo>
                  <a:lnTo>
                    <a:pt x="4803507" y="0"/>
                  </a:lnTo>
                  <a:lnTo>
                    <a:pt x="4803507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" name="pl10"/>
            <p:cNvSpPr/>
            <p:nvPr/>
          </p:nvSpPr>
          <p:spPr>
            <a:xfrm>
              <a:off x="1828282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" name="pl11"/>
            <p:cNvSpPr/>
            <p:nvPr/>
          </p:nvSpPr>
          <p:spPr>
            <a:xfrm>
              <a:off x="3061848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" name="pl12"/>
            <p:cNvSpPr/>
            <p:nvPr/>
          </p:nvSpPr>
          <p:spPr>
            <a:xfrm>
              <a:off x="4295415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" name="pl13"/>
            <p:cNvSpPr/>
            <p:nvPr/>
          </p:nvSpPr>
          <p:spPr>
            <a:xfrm>
              <a:off x="5528981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" name="pl14"/>
            <p:cNvSpPr/>
            <p:nvPr/>
          </p:nvSpPr>
          <p:spPr>
            <a:xfrm>
              <a:off x="1527703" y="5896482"/>
              <a:ext cx="4803507" cy="0"/>
            </a:xfrm>
            <a:custGeom>
              <a:avLst/>
              <a:pathLst>
                <a:path w="4803507" h="0">
                  <a:moveTo>
                    <a:pt x="0" y="0"/>
                  </a:moveTo>
                  <a:lnTo>
                    <a:pt x="4803507" y="0"/>
                  </a:lnTo>
                  <a:lnTo>
                    <a:pt x="4803507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" name="pl15"/>
            <p:cNvSpPr/>
            <p:nvPr/>
          </p:nvSpPr>
          <p:spPr>
            <a:xfrm>
              <a:off x="1527703" y="4961043"/>
              <a:ext cx="4803507" cy="0"/>
            </a:xfrm>
            <a:custGeom>
              <a:avLst/>
              <a:pathLst>
                <a:path w="4803507" h="0">
                  <a:moveTo>
                    <a:pt x="0" y="0"/>
                  </a:moveTo>
                  <a:lnTo>
                    <a:pt x="4803507" y="0"/>
                  </a:lnTo>
                  <a:lnTo>
                    <a:pt x="4803507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" name="pl16"/>
            <p:cNvSpPr/>
            <p:nvPr/>
          </p:nvSpPr>
          <p:spPr>
            <a:xfrm>
              <a:off x="1527703" y="4025604"/>
              <a:ext cx="4803507" cy="0"/>
            </a:xfrm>
            <a:custGeom>
              <a:avLst/>
              <a:pathLst>
                <a:path w="4803507" h="0">
                  <a:moveTo>
                    <a:pt x="0" y="0"/>
                  </a:moveTo>
                  <a:lnTo>
                    <a:pt x="4803507" y="0"/>
                  </a:lnTo>
                  <a:lnTo>
                    <a:pt x="4803507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" name="pl17"/>
            <p:cNvSpPr/>
            <p:nvPr/>
          </p:nvSpPr>
          <p:spPr>
            <a:xfrm>
              <a:off x="1527703" y="3090165"/>
              <a:ext cx="4803507" cy="0"/>
            </a:xfrm>
            <a:custGeom>
              <a:avLst/>
              <a:pathLst>
                <a:path w="4803507" h="0">
                  <a:moveTo>
                    <a:pt x="0" y="0"/>
                  </a:moveTo>
                  <a:lnTo>
                    <a:pt x="4803507" y="0"/>
                  </a:lnTo>
                  <a:lnTo>
                    <a:pt x="4803507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" name="pl18"/>
            <p:cNvSpPr/>
            <p:nvPr/>
          </p:nvSpPr>
          <p:spPr>
            <a:xfrm>
              <a:off x="1527703" y="2154726"/>
              <a:ext cx="4803507" cy="0"/>
            </a:xfrm>
            <a:custGeom>
              <a:avLst/>
              <a:pathLst>
                <a:path w="4803507" h="0">
                  <a:moveTo>
                    <a:pt x="0" y="0"/>
                  </a:moveTo>
                  <a:lnTo>
                    <a:pt x="4803507" y="0"/>
                  </a:lnTo>
                  <a:lnTo>
                    <a:pt x="4803507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" name="pl19"/>
            <p:cNvSpPr/>
            <p:nvPr/>
          </p:nvSpPr>
          <p:spPr>
            <a:xfrm>
              <a:off x="2445065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" name="pl20"/>
            <p:cNvSpPr/>
            <p:nvPr/>
          </p:nvSpPr>
          <p:spPr>
            <a:xfrm>
              <a:off x="3678631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" name="pl21"/>
            <p:cNvSpPr/>
            <p:nvPr/>
          </p:nvSpPr>
          <p:spPr>
            <a:xfrm>
              <a:off x="4912198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" name="pl22"/>
            <p:cNvSpPr/>
            <p:nvPr/>
          </p:nvSpPr>
          <p:spPr>
            <a:xfrm>
              <a:off x="6145764" y="1900246"/>
              <a:ext cx="0" cy="4100620"/>
            </a:xfrm>
            <a:custGeom>
              <a:avLst/>
              <a:pathLst>
                <a:path w="0" h="4100620">
                  <a:moveTo>
                    <a:pt x="0" y="410062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" name="pl23"/>
            <p:cNvSpPr/>
            <p:nvPr/>
          </p:nvSpPr>
          <p:spPr>
            <a:xfrm>
              <a:off x="2732897" y="356773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" name="pl24"/>
            <p:cNvSpPr/>
            <p:nvPr/>
          </p:nvSpPr>
          <p:spPr>
            <a:xfrm>
              <a:off x="2732897" y="3567733"/>
              <a:ext cx="0" cy="1843675"/>
            </a:xfrm>
            <a:custGeom>
              <a:avLst/>
              <a:pathLst>
                <a:path w="0" h="1843675">
                  <a:moveTo>
                    <a:pt x="0" y="0"/>
                  </a:moveTo>
                  <a:lnTo>
                    <a:pt x="0" y="184367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" name="pl25"/>
            <p:cNvSpPr/>
            <p:nvPr/>
          </p:nvSpPr>
          <p:spPr>
            <a:xfrm>
              <a:off x="2732897" y="54114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" name="pl26"/>
            <p:cNvSpPr/>
            <p:nvPr/>
          </p:nvSpPr>
          <p:spPr>
            <a:xfrm>
              <a:off x="3226324" y="31858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" name="pl27"/>
            <p:cNvSpPr/>
            <p:nvPr/>
          </p:nvSpPr>
          <p:spPr>
            <a:xfrm>
              <a:off x="3226324" y="3185868"/>
              <a:ext cx="0" cy="2628606"/>
            </a:xfrm>
            <a:custGeom>
              <a:avLst/>
              <a:pathLst>
                <a:path w="0" h="2628606">
                  <a:moveTo>
                    <a:pt x="0" y="0"/>
                  </a:moveTo>
                  <a:lnTo>
                    <a:pt x="0" y="262860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" name="pl28"/>
            <p:cNvSpPr/>
            <p:nvPr/>
          </p:nvSpPr>
          <p:spPr>
            <a:xfrm>
              <a:off x="3226324" y="58144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" name="pl29"/>
            <p:cNvSpPr/>
            <p:nvPr/>
          </p:nvSpPr>
          <p:spPr>
            <a:xfrm>
              <a:off x="4501009" y="26860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" name="pl30"/>
            <p:cNvSpPr/>
            <p:nvPr/>
          </p:nvSpPr>
          <p:spPr>
            <a:xfrm>
              <a:off x="4501009" y="2686059"/>
              <a:ext cx="0" cy="2360651"/>
            </a:xfrm>
            <a:custGeom>
              <a:avLst/>
              <a:pathLst>
                <a:path w="0" h="2360651">
                  <a:moveTo>
                    <a:pt x="0" y="0"/>
                  </a:moveTo>
                  <a:lnTo>
                    <a:pt x="0" y="2360651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" name="pl31"/>
            <p:cNvSpPr/>
            <p:nvPr/>
          </p:nvSpPr>
          <p:spPr>
            <a:xfrm>
              <a:off x="4501009" y="50467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" name="pl32"/>
            <p:cNvSpPr/>
            <p:nvPr/>
          </p:nvSpPr>
          <p:spPr>
            <a:xfrm>
              <a:off x="5734576" y="22658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" name="pl33"/>
            <p:cNvSpPr/>
            <p:nvPr/>
          </p:nvSpPr>
          <p:spPr>
            <a:xfrm>
              <a:off x="5734576" y="2265879"/>
              <a:ext cx="0" cy="1760196"/>
            </a:xfrm>
            <a:custGeom>
              <a:avLst/>
              <a:pathLst>
                <a:path w="0" h="1760196">
                  <a:moveTo>
                    <a:pt x="0" y="0"/>
                  </a:moveTo>
                  <a:lnTo>
                    <a:pt x="0" y="1760196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" name="pl34"/>
            <p:cNvSpPr/>
            <p:nvPr/>
          </p:nvSpPr>
          <p:spPr>
            <a:xfrm>
              <a:off x="5734576" y="40260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" name="pl35"/>
            <p:cNvSpPr/>
            <p:nvPr/>
          </p:nvSpPr>
          <p:spPr>
            <a:xfrm>
              <a:off x="2116114" y="355649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" name="pl36"/>
            <p:cNvSpPr/>
            <p:nvPr/>
          </p:nvSpPr>
          <p:spPr>
            <a:xfrm>
              <a:off x="2116114" y="3556493"/>
              <a:ext cx="0" cy="1782205"/>
            </a:xfrm>
            <a:custGeom>
              <a:avLst/>
              <a:pathLst>
                <a:path w="0" h="1782205">
                  <a:moveTo>
                    <a:pt x="0" y="0"/>
                  </a:moveTo>
                  <a:lnTo>
                    <a:pt x="0" y="1782205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" name="pl37"/>
            <p:cNvSpPr/>
            <p:nvPr/>
          </p:nvSpPr>
          <p:spPr>
            <a:xfrm>
              <a:off x="2116114" y="53386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" name="pl38"/>
            <p:cNvSpPr/>
            <p:nvPr/>
          </p:nvSpPr>
          <p:spPr>
            <a:xfrm>
              <a:off x="4048701" y="20866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" name="pl39"/>
            <p:cNvSpPr/>
            <p:nvPr/>
          </p:nvSpPr>
          <p:spPr>
            <a:xfrm>
              <a:off x="4048701" y="2086637"/>
              <a:ext cx="0" cy="2239673"/>
            </a:xfrm>
            <a:custGeom>
              <a:avLst/>
              <a:pathLst>
                <a:path w="0" h="2239673">
                  <a:moveTo>
                    <a:pt x="0" y="0"/>
                  </a:moveTo>
                  <a:lnTo>
                    <a:pt x="0" y="2239673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" name="pl40"/>
            <p:cNvSpPr/>
            <p:nvPr/>
          </p:nvSpPr>
          <p:spPr>
            <a:xfrm>
              <a:off x="4048701" y="432631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" name="pl41"/>
            <p:cNvSpPr/>
            <p:nvPr/>
          </p:nvSpPr>
          <p:spPr>
            <a:xfrm>
              <a:off x="3185205" y="44895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" name="pl42"/>
            <p:cNvSpPr/>
            <p:nvPr/>
          </p:nvSpPr>
          <p:spPr>
            <a:xfrm>
              <a:off x="2280590" y="4489571"/>
              <a:ext cx="904615" cy="0"/>
            </a:xfrm>
            <a:custGeom>
              <a:avLst/>
              <a:pathLst>
                <a:path w="904615" h="0">
                  <a:moveTo>
                    <a:pt x="90461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" name="pl43"/>
            <p:cNvSpPr/>
            <p:nvPr/>
          </p:nvSpPr>
          <p:spPr>
            <a:xfrm>
              <a:off x="2280590" y="44895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" name="pl44"/>
            <p:cNvSpPr/>
            <p:nvPr/>
          </p:nvSpPr>
          <p:spPr>
            <a:xfrm>
              <a:off x="3760869" y="45001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" name="pl45"/>
            <p:cNvSpPr/>
            <p:nvPr/>
          </p:nvSpPr>
          <p:spPr>
            <a:xfrm>
              <a:off x="2691778" y="4500171"/>
              <a:ext cx="1069090" cy="0"/>
            </a:xfrm>
            <a:custGeom>
              <a:avLst/>
              <a:pathLst>
                <a:path w="1069090" h="0">
                  <a:moveTo>
                    <a:pt x="106909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" name="pl46"/>
            <p:cNvSpPr/>
            <p:nvPr/>
          </p:nvSpPr>
          <p:spPr>
            <a:xfrm>
              <a:off x="2691778" y="450017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" name="pl47"/>
            <p:cNvSpPr/>
            <p:nvPr/>
          </p:nvSpPr>
          <p:spPr>
            <a:xfrm>
              <a:off x="4994436" y="38663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" name="pl48"/>
            <p:cNvSpPr/>
            <p:nvPr/>
          </p:nvSpPr>
          <p:spPr>
            <a:xfrm>
              <a:off x="4007583" y="3866385"/>
              <a:ext cx="986853" cy="0"/>
            </a:xfrm>
            <a:custGeom>
              <a:avLst/>
              <a:pathLst>
                <a:path w="986853" h="0">
                  <a:moveTo>
                    <a:pt x="986853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" name="pl49"/>
            <p:cNvSpPr/>
            <p:nvPr/>
          </p:nvSpPr>
          <p:spPr>
            <a:xfrm>
              <a:off x="4007583" y="38663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" name="pl50"/>
            <p:cNvSpPr/>
            <p:nvPr/>
          </p:nvSpPr>
          <p:spPr>
            <a:xfrm>
              <a:off x="6112869" y="31459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" name="pl51"/>
            <p:cNvSpPr/>
            <p:nvPr/>
          </p:nvSpPr>
          <p:spPr>
            <a:xfrm>
              <a:off x="5356282" y="3145977"/>
              <a:ext cx="756587" cy="0"/>
            </a:xfrm>
            <a:custGeom>
              <a:avLst/>
              <a:pathLst>
                <a:path w="756587" h="0">
                  <a:moveTo>
                    <a:pt x="756587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" name="pl52"/>
            <p:cNvSpPr/>
            <p:nvPr/>
          </p:nvSpPr>
          <p:spPr>
            <a:xfrm>
              <a:off x="5356282" y="31459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" name="pl53"/>
            <p:cNvSpPr/>
            <p:nvPr/>
          </p:nvSpPr>
          <p:spPr>
            <a:xfrm>
              <a:off x="2486184" y="44475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" name="pl54"/>
            <p:cNvSpPr/>
            <p:nvPr/>
          </p:nvSpPr>
          <p:spPr>
            <a:xfrm>
              <a:off x="1746044" y="4447596"/>
              <a:ext cx="740139" cy="0"/>
            </a:xfrm>
            <a:custGeom>
              <a:avLst/>
              <a:pathLst>
                <a:path w="740139" h="0">
                  <a:moveTo>
                    <a:pt x="740139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" name="pl55"/>
            <p:cNvSpPr/>
            <p:nvPr/>
          </p:nvSpPr>
          <p:spPr>
            <a:xfrm>
              <a:off x="1746044" y="44475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" name="pl56"/>
            <p:cNvSpPr/>
            <p:nvPr/>
          </p:nvSpPr>
          <p:spPr>
            <a:xfrm>
              <a:off x="4501009" y="32064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" name="pl57"/>
            <p:cNvSpPr/>
            <p:nvPr/>
          </p:nvSpPr>
          <p:spPr>
            <a:xfrm>
              <a:off x="3596394" y="3206474"/>
              <a:ext cx="904615" cy="0"/>
            </a:xfrm>
            <a:custGeom>
              <a:avLst/>
              <a:pathLst>
                <a:path w="904615" h="0">
                  <a:moveTo>
                    <a:pt x="904615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" name="pl58"/>
            <p:cNvSpPr/>
            <p:nvPr/>
          </p:nvSpPr>
          <p:spPr>
            <a:xfrm>
              <a:off x="3596394" y="32064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" name="pt59"/>
            <p:cNvSpPr/>
            <p:nvPr/>
          </p:nvSpPr>
          <p:spPr>
            <a:xfrm>
              <a:off x="2708071" y="446474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" name="pt60"/>
            <p:cNvSpPr/>
            <p:nvPr/>
          </p:nvSpPr>
          <p:spPr>
            <a:xfrm>
              <a:off x="3201498" y="447534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" name="pt61"/>
            <p:cNvSpPr/>
            <p:nvPr/>
          </p:nvSpPr>
          <p:spPr>
            <a:xfrm>
              <a:off x="4476183" y="384155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" name="pt62"/>
            <p:cNvSpPr/>
            <p:nvPr/>
          </p:nvSpPr>
          <p:spPr>
            <a:xfrm>
              <a:off x="5709750" y="312115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" name="pt63"/>
            <p:cNvSpPr/>
            <p:nvPr/>
          </p:nvSpPr>
          <p:spPr>
            <a:xfrm>
              <a:off x="2091288" y="442277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" name="pt64"/>
            <p:cNvSpPr/>
            <p:nvPr/>
          </p:nvSpPr>
          <p:spPr>
            <a:xfrm>
              <a:off x="4023875" y="318164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" name="pl65"/>
            <p:cNvSpPr/>
            <p:nvPr/>
          </p:nvSpPr>
          <p:spPr>
            <a:xfrm>
              <a:off x="1527703" y="3119452"/>
              <a:ext cx="4803507" cy="1392367"/>
            </a:xfrm>
            <a:custGeom>
              <a:avLst/>
              <a:pathLst>
                <a:path w="4803507" h="1392367">
                  <a:moveTo>
                    <a:pt x="0" y="1392367"/>
                  </a:moveTo>
                  <a:lnTo>
                    <a:pt x="4803507" y="0"/>
                  </a:lnTo>
                </a:path>
              </a:pathLst>
            </a:custGeom>
            <a:ln w="13550" cap="flat">
              <a:solidFill>
                <a:srgbClr val="A6CEE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" name="pl66"/>
            <p:cNvSpPr/>
            <p:nvPr/>
          </p:nvSpPr>
          <p:spPr>
            <a:xfrm>
              <a:off x="1527703" y="2881803"/>
              <a:ext cx="4803507" cy="1924470"/>
            </a:xfrm>
            <a:custGeom>
              <a:avLst/>
              <a:pathLst>
                <a:path w="4803507" h="1924470">
                  <a:moveTo>
                    <a:pt x="0" y="1924470"/>
                  </a:moveTo>
                  <a:lnTo>
                    <a:pt x="4803507" y="0"/>
                  </a:lnTo>
                </a:path>
              </a:pathLst>
            </a:custGeom>
            <a:ln w="13550" cap="flat">
              <a:solidFill>
                <a:srgbClr val="1F78B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" name="pl67"/>
            <p:cNvSpPr/>
            <p:nvPr/>
          </p:nvSpPr>
          <p:spPr>
            <a:xfrm>
              <a:off x="1527703" y="3142030"/>
              <a:ext cx="4803507" cy="1375296"/>
            </a:xfrm>
            <a:custGeom>
              <a:avLst/>
              <a:pathLst>
                <a:path w="4803507" h="1375296">
                  <a:moveTo>
                    <a:pt x="0" y="1375296"/>
                  </a:moveTo>
                  <a:lnTo>
                    <a:pt x="4803507" y="0"/>
                  </a:lnTo>
                </a:path>
              </a:pathLst>
            </a:custGeom>
            <a:ln w="13550" cap="flat">
              <a:solidFill>
                <a:srgbClr val="B2DF8A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" name="pl68"/>
            <p:cNvSpPr/>
            <p:nvPr/>
          </p:nvSpPr>
          <p:spPr>
            <a:xfrm>
              <a:off x="1527703" y="3085868"/>
              <a:ext cx="4803507" cy="1417758"/>
            </a:xfrm>
            <a:custGeom>
              <a:avLst/>
              <a:pathLst>
                <a:path w="4803507" h="1417758">
                  <a:moveTo>
                    <a:pt x="0" y="1417758"/>
                  </a:moveTo>
                  <a:lnTo>
                    <a:pt x="4803507" y="0"/>
                  </a:lnTo>
                </a:path>
              </a:pathLst>
            </a:custGeom>
            <a:ln w="13550" cap="flat">
              <a:solidFill>
                <a:srgbClr val="33A02C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" name="tx69"/>
            <p:cNvSpPr/>
            <p:nvPr/>
          </p:nvSpPr>
          <p:spPr>
            <a:xfrm>
              <a:off x="1148183" y="5854791"/>
              <a:ext cx="316889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-0.025</a:t>
              </a:r>
            </a:p>
          </p:txBody>
        </p:sp>
        <p:sp>
          <p:nvSpPr>
            <p:cNvPr id="71" name="tx70"/>
            <p:cNvSpPr/>
            <p:nvPr/>
          </p:nvSpPr>
          <p:spPr>
            <a:xfrm>
              <a:off x="1185400" y="4919352"/>
              <a:ext cx="279672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00</a:t>
              </a:r>
            </a:p>
          </p:txBody>
        </p:sp>
        <p:sp>
          <p:nvSpPr>
            <p:cNvPr id="72" name="tx71"/>
            <p:cNvSpPr/>
            <p:nvPr/>
          </p:nvSpPr>
          <p:spPr>
            <a:xfrm>
              <a:off x="1185400" y="3983913"/>
              <a:ext cx="279672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25</a:t>
              </a:r>
            </a:p>
          </p:txBody>
        </p:sp>
        <p:sp>
          <p:nvSpPr>
            <p:cNvPr id="73" name="tx72"/>
            <p:cNvSpPr/>
            <p:nvPr/>
          </p:nvSpPr>
          <p:spPr>
            <a:xfrm>
              <a:off x="1185400" y="3048473"/>
              <a:ext cx="279672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50</a:t>
              </a:r>
            </a:p>
          </p:txBody>
        </p:sp>
        <p:sp>
          <p:nvSpPr>
            <p:cNvPr id="74" name="tx73"/>
            <p:cNvSpPr/>
            <p:nvPr/>
          </p:nvSpPr>
          <p:spPr>
            <a:xfrm>
              <a:off x="1185400" y="2113034"/>
              <a:ext cx="279672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75</a:t>
              </a:r>
            </a:p>
          </p:txBody>
        </p:sp>
        <p:sp>
          <p:nvSpPr>
            <p:cNvPr id="75" name="pl74"/>
            <p:cNvSpPr/>
            <p:nvPr/>
          </p:nvSpPr>
          <p:spPr>
            <a:xfrm>
              <a:off x="1492908" y="589648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" name="pl75"/>
            <p:cNvSpPr/>
            <p:nvPr/>
          </p:nvSpPr>
          <p:spPr>
            <a:xfrm>
              <a:off x="1492908" y="496104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" name="pl76"/>
            <p:cNvSpPr/>
            <p:nvPr/>
          </p:nvSpPr>
          <p:spPr>
            <a:xfrm>
              <a:off x="1492908" y="402560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" name="pl77"/>
            <p:cNvSpPr/>
            <p:nvPr/>
          </p:nvSpPr>
          <p:spPr>
            <a:xfrm>
              <a:off x="1492908" y="309016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" name="pl78"/>
            <p:cNvSpPr/>
            <p:nvPr/>
          </p:nvSpPr>
          <p:spPr>
            <a:xfrm>
              <a:off x="1492908" y="215472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" name="pl79"/>
            <p:cNvSpPr/>
            <p:nvPr/>
          </p:nvSpPr>
          <p:spPr>
            <a:xfrm>
              <a:off x="2445065" y="6000866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" name="pl80"/>
            <p:cNvSpPr/>
            <p:nvPr/>
          </p:nvSpPr>
          <p:spPr>
            <a:xfrm>
              <a:off x="3678631" y="6000866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" name="pl81"/>
            <p:cNvSpPr/>
            <p:nvPr/>
          </p:nvSpPr>
          <p:spPr>
            <a:xfrm>
              <a:off x="4912198" y="6000866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" name="pl82"/>
            <p:cNvSpPr/>
            <p:nvPr/>
          </p:nvSpPr>
          <p:spPr>
            <a:xfrm>
              <a:off x="6145764" y="6000866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" name="tx83"/>
            <p:cNvSpPr/>
            <p:nvPr/>
          </p:nvSpPr>
          <p:spPr>
            <a:xfrm>
              <a:off x="2336306" y="6061805"/>
              <a:ext cx="217517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6</a:t>
              </a:r>
            </a:p>
          </p:txBody>
        </p:sp>
        <p:sp>
          <p:nvSpPr>
            <p:cNvPr id="85" name="tx84"/>
            <p:cNvSpPr/>
            <p:nvPr/>
          </p:nvSpPr>
          <p:spPr>
            <a:xfrm>
              <a:off x="3569873" y="6061805"/>
              <a:ext cx="217517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09</a:t>
              </a:r>
            </a:p>
          </p:txBody>
        </p:sp>
        <p:sp>
          <p:nvSpPr>
            <p:cNvPr id="86" name="tx85"/>
            <p:cNvSpPr/>
            <p:nvPr/>
          </p:nvSpPr>
          <p:spPr>
            <a:xfrm>
              <a:off x="4803439" y="6061805"/>
              <a:ext cx="217517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12</a:t>
              </a:r>
            </a:p>
          </p:txBody>
        </p:sp>
        <p:sp>
          <p:nvSpPr>
            <p:cNvPr id="87" name="tx86"/>
            <p:cNvSpPr/>
            <p:nvPr/>
          </p:nvSpPr>
          <p:spPr>
            <a:xfrm>
              <a:off x="6037006" y="6061805"/>
              <a:ext cx="217517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.15</a:t>
              </a:r>
            </a:p>
          </p:txBody>
        </p:sp>
        <p:sp>
          <p:nvSpPr>
            <p:cNvPr id="88" name="tx87"/>
            <p:cNvSpPr/>
            <p:nvPr/>
          </p:nvSpPr>
          <p:spPr>
            <a:xfrm>
              <a:off x="2720656" y="6170637"/>
              <a:ext cx="2417601" cy="13117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SNP effect on Overweight || id:ieu-a-93</a:t>
              </a:r>
            </a:p>
          </p:txBody>
        </p:sp>
        <p:sp>
          <p:nvSpPr>
            <p:cNvPr id="89" name="tx88"/>
            <p:cNvSpPr/>
            <p:nvPr/>
          </p:nvSpPr>
          <p:spPr>
            <a:xfrm rot="-5400000">
              <a:off x="-1130064" y="3884969"/>
              <a:ext cx="4296934" cy="131173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SNP effect on Pilonidal cyst || id:finngen_R12_L12_PILONIDALCYST</a:t>
              </a:r>
            </a:p>
          </p:txBody>
        </p:sp>
        <p:sp>
          <p:nvSpPr>
            <p:cNvPr id="90" name="rc89"/>
            <p:cNvSpPr/>
            <p:nvPr/>
          </p:nvSpPr>
          <p:spPr>
            <a:xfrm>
              <a:off x="2451962" y="983989"/>
              <a:ext cx="2954990" cy="777078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91" name="tx90"/>
            <p:cNvSpPr/>
            <p:nvPr/>
          </p:nvSpPr>
          <p:spPr>
            <a:xfrm>
              <a:off x="2521551" y="1066640"/>
              <a:ext cx="527763" cy="10163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11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1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R Test</a:t>
              </a:r>
            </a:p>
          </p:txBody>
        </p:sp>
        <p:sp>
          <p:nvSpPr>
            <p:cNvPr id="92" name="rc91"/>
            <p:cNvSpPr/>
            <p:nvPr/>
          </p:nvSpPr>
          <p:spPr>
            <a:xfrm>
              <a:off x="2521551" y="1252566"/>
              <a:ext cx="219456" cy="219456"/>
            </a:xfrm>
            <a:prstGeom prst="rect">
              <a:avLst/>
            </a:prstGeom>
            <a:solidFill>
              <a:srgbClr val="F2F2F2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93" name="pl92"/>
            <p:cNvSpPr/>
            <p:nvPr/>
          </p:nvSpPr>
          <p:spPr>
            <a:xfrm>
              <a:off x="2521551" y="1252566"/>
              <a:ext cx="219456" cy="219455"/>
            </a:xfrm>
            <a:custGeom>
              <a:avLst/>
              <a:pathLst>
                <a:path w="219456" h="219455">
                  <a:moveTo>
                    <a:pt x="0" y="219455"/>
                  </a:moveTo>
                  <a:lnTo>
                    <a:pt x="219456" y="0"/>
                  </a:lnTo>
                </a:path>
              </a:pathLst>
            </a:custGeom>
            <a:ln w="13550" cap="flat">
              <a:solidFill>
                <a:srgbClr val="A6CEE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" name="rc93"/>
            <p:cNvSpPr/>
            <p:nvPr/>
          </p:nvSpPr>
          <p:spPr>
            <a:xfrm>
              <a:off x="2521551" y="1472022"/>
              <a:ext cx="219456" cy="219456"/>
            </a:xfrm>
            <a:prstGeom prst="rect">
              <a:avLst/>
            </a:prstGeom>
            <a:solidFill>
              <a:srgbClr val="F2F2F2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95" name="pl94"/>
            <p:cNvSpPr/>
            <p:nvPr/>
          </p:nvSpPr>
          <p:spPr>
            <a:xfrm>
              <a:off x="2521551" y="1472022"/>
              <a:ext cx="219456" cy="219456"/>
            </a:xfrm>
            <a:custGeom>
              <a:avLst/>
              <a:pathLst>
                <a:path w="219456" h="219456">
                  <a:moveTo>
                    <a:pt x="0" y="219456"/>
                  </a:moveTo>
                  <a:lnTo>
                    <a:pt x="219456" y="0"/>
                  </a:lnTo>
                </a:path>
              </a:pathLst>
            </a:custGeom>
            <a:ln w="13550" cap="flat">
              <a:solidFill>
                <a:srgbClr val="1F78B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" name="rc95"/>
            <p:cNvSpPr/>
            <p:nvPr/>
          </p:nvSpPr>
          <p:spPr>
            <a:xfrm>
              <a:off x="4178576" y="1252566"/>
              <a:ext cx="219455" cy="219456"/>
            </a:xfrm>
            <a:prstGeom prst="rect">
              <a:avLst/>
            </a:prstGeom>
            <a:solidFill>
              <a:srgbClr val="F2F2F2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97" name="pl96"/>
            <p:cNvSpPr/>
            <p:nvPr/>
          </p:nvSpPr>
          <p:spPr>
            <a:xfrm>
              <a:off x="4178576" y="1252566"/>
              <a:ext cx="219455" cy="219455"/>
            </a:xfrm>
            <a:custGeom>
              <a:avLst/>
              <a:pathLst>
                <a:path w="219455" h="219455">
                  <a:moveTo>
                    <a:pt x="0" y="219455"/>
                  </a:moveTo>
                  <a:lnTo>
                    <a:pt x="219455" y="0"/>
                  </a:lnTo>
                </a:path>
              </a:pathLst>
            </a:custGeom>
            <a:ln w="13550" cap="flat">
              <a:solidFill>
                <a:srgbClr val="B2DF8A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" name="rc97"/>
            <p:cNvSpPr/>
            <p:nvPr/>
          </p:nvSpPr>
          <p:spPr>
            <a:xfrm>
              <a:off x="4178576" y="1472022"/>
              <a:ext cx="219455" cy="219456"/>
            </a:xfrm>
            <a:prstGeom prst="rect">
              <a:avLst/>
            </a:prstGeom>
            <a:solidFill>
              <a:srgbClr val="F2F2F2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99" name="pl98"/>
            <p:cNvSpPr/>
            <p:nvPr/>
          </p:nvSpPr>
          <p:spPr>
            <a:xfrm>
              <a:off x="4178576" y="1472022"/>
              <a:ext cx="219455" cy="219456"/>
            </a:xfrm>
            <a:custGeom>
              <a:avLst/>
              <a:pathLst>
                <a:path w="219455" h="219456">
                  <a:moveTo>
                    <a:pt x="0" y="219456"/>
                  </a:moveTo>
                  <a:lnTo>
                    <a:pt x="219455" y="0"/>
                  </a:lnTo>
                </a:path>
              </a:pathLst>
            </a:custGeom>
            <a:ln w="13550" cap="flat">
              <a:solidFill>
                <a:srgbClr val="33A02C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" name="tx99"/>
            <p:cNvSpPr/>
            <p:nvPr/>
          </p:nvSpPr>
          <p:spPr>
            <a:xfrm>
              <a:off x="2810596" y="1298775"/>
              <a:ext cx="1298391" cy="10351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Inverse variance weighted</a:t>
              </a:r>
            </a:p>
          </p:txBody>
        </p:sp>
        <p:sp>
          <p:nvSpPr>
            <p:cNvPr id="101" name="tx100"/>
            <p:cNvSpPr/>
            <p:nvPr/>
          </p:nvSpPr>
          <p:spPr>
            <a:xfrm>
              <a:off x="2810596" y="1518231"/>
              <a:ext cx="503083" cy="10351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R Egger</a:t>
              </a:r>
            </a:p>
          </p:txBody>
        </p:sp>
        <p:sp>
          <p:nvSpPr>
            <p:cNvPr id="102" name="tx101"/>
            <p:cNvSpPr/>
            <p:nvPr/>
          </p:nvSpPr>
          <p:spPr>
            <a:xfrm>
              <a:off x="4467621" y="1298775"/>
              <a:ext cx="869741" cy="10351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Weighted median</a:t>
              </a:r>
            </a:p>
          </p:txBody>
        </p:sp>
        <p:sp>
          <p:nvSpPr>
            <p:cNvPr id="103" name="tx102"/>
            <p:cNvSpPr/>
            <p:nvPr/>
          </p:nvSpPr>
          <p:spPr>
            <a:xfrm>
              <a:off x="4467621" y="1518231"/>
              <a:ext cx="782756" cy="103519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Weighted mode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Macintosh PowerPoint</Application>
  <PresentationFormat>Présentation à l'écran (4:3)</PresentationFormat>
  <Paragraphs>0</Paragraphs>
  <Slides>0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0</vt:i4>
      </vt:variant>
    </vt:vector>
  </HeadingPairs>
  <TitlesOfParts>
    <vt:vector size="1" baseType="lpstr">
      <vt:lpstr>Office Theme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mitype="http://purl.org/dc/dcmitype/" xmlns:dcterms="http://purl.org/dc/terms/" xmlns:xsi="http://www.w3.org/2001/XMLSchema-instance">
  <dc:title/>
  <dc:subject/>
  <dc:creator/>
  <cp:keywords/>
  <dc:description/>
  <cp:lastModifiedBy/>
  <cp:revision>3</cp:revision>
  <dcterms:created xsi:type="dcterms:W3CDTF">2017-02-13T16:18:36Z</dcterms:created>
  <dcterms:modified xsi:type="dcterms:W3CDTF">2025-06-26T23:38:59Z</dcterms:modified>
  <cp:category/>
</cp:coreProperties>
</file>